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1443" autoAdjust="0"/>
  </p:normalViewPr>
  <p:slideViewPr>
    <p:cSldViewPr snapToGrid="0">
      <p:cViewPr>
        <p:scale>
          <a:sx n="30" d="100"/>
          <a:sy n="30" d="100"/>
        </p:scale>
        <p:origin x="2100" y="1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738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679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901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746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678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741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884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700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456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89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73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E3200-44E0-4CDA-A8B6-A20E156BF1B1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1DFFF-94BF-44C7-98D6-D1ECFF0EC5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674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0"/>
            <a:ext cx="10724147" cy="14245389"/>
            <a:chOff x="1467853" y="0"/>
            <a:chExt cx="10724147" cy="14245389"/>
          </a:xfrm>
        </p:grpSpPr>
        <p:sp>
          <p:nvSpPr>
            <p:cNvPr id="376" name="Rectangle 375"/>
            <p:cNvSpPr/>
            <p:nvPr/>
          </p:nvSpPr>
          <p:spPr>
            <a:xfrm>
              <a:off x="1467853" y="0"/>
              <a:ext cx="10724147" cy="1424538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3000"/>
                      </a14:imgEffect>
                      <a14:imgEffect>
                        <a14:brightnessContrast contras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8" t="110" r="46692" b="1765"/>
            <a:stretch/>
          </p:blipFill>
          <p:spPr>
            <a:xfrm>
              <a:off x="2333625" y="371474"/>
              <a:ext cx="4057650" cy="13458825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857375" y="4147661"/>
              <a:ext cx="1143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 smtClean="0"/>
                <a:t>Nur</a:t>
              </a:r>
              <a:endParaRPr lang="en-US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847850" y="8181975"/>
              <a:ext cx="1143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 smtClean="0"/>
                <a:t>Zur</a:t>
              </a:r>
              <a:endParaRPr lang="en-US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847850" y="5799177"/>
              <a:ext cx="1143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err="1" smtClean="0"/>
                <a:t>PerR</a:t>
              </a:r>
              <a:endParaRPr lang="en-US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97854" y="12916403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*Fur</a:t>
              </a:r>
              <a:endParaRPr lang="en-US" sz="12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181475" y="13210787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*Mur</a:t>
              </a:r>
              <a:endParaRPr lang="en-US" sz="12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62375" y="9058275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*</a:t>
              </a:r>
              <a:r>
                <a:rPr lang="en-US" sz="1200" b="1" dirty="0" err="1" smtClean="0"/>
                <a:t>Zur</a:t>
              </a:r>
              <a:endParaRPr lang="en-US" sz="12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324350" y="8896544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*</a:t>
              </a:r>
              <a:r>
                <a:rPr lang="en-US" sz="1200" b="1" dirty="0" err="1" smtClean="0"/>
                <a:t>Zur</a:t>
              </a:r>
              <a:endParaRPr lang="en-US" sz="12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362450" y="9753794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*</a:t>
              </a:r>
              <a:r>
                <a:rPr lang="en-US" sz="1200" b="1" dirty="0" err="1" smtClean="0"/>
                <a:t>Zur</a:t>
              </a:r>
              <a:endParaRPr lang="en-US" sz="12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114800" y="4289851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*</a:t>
              </a:r>
              <a:r>
                <a:rPr lang="en-US" sz="1200" b="1" dirty="0" err="1"/>
                <a:t>N</a:t>
              </a:r>
              <a:r>
                <a:rPr lang="en-US" sz="1200" b="1" dirty="0" err="1" smtClean="0"/>
                <a:t>ur</a:t>
              </a:r>
              <a:endParaRPr lang="en-US" sz="12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164705" y="5171894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Rubrerythrin</a:t>
              </a:r>
              <a:endParaRPr lang="en-US" sz="1200" b="1" dirty="0"/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>
              <a:off x="7653977" y="5432458"/>
              <a:ext cx="9525" cy="24651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9" name="Picture 311" descr="https://img.jgi.doe.gov/w/tmp/ScaffoldPanel.gn.orth.2508504278.536923.x.537468.26118.pn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05450" y="3947762"/>
              <a:ext cx="4454063" cy="4264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4" name="Picture 386" descr="https://img.jgi.doe.gov/w/tmp/ScaffoldPanel.gn.orth.637000153.4590561.x.4590998.26118.png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05450" y="3633845"/>
              <a:ext cx="4454063" cy="4264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8" name="TextBox 257"/>
            <p:cNvSpPr txBox="1"/>
            <p:nvPr/>
          </p:nvSpPr>
          <p:spPr>
            <a:xfrm>
              <a:off x="7659501" y="3264834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YgfZ</a:t>
              </a:r>
              <a:endParaRPr lang="en-US" sz="1200" b="1" dirty="0"/>
            </a:p>
          </p:txBody>
        </p:sp>
        <p:cxnSp>
          <p:nvCxnSpPr>
            <p:cNvPr id="259" name="Straight Arrow Connector 258"/>
            <p:cNvCxnSpPr/>
            <p:nvPr/>
          </p:nvCxnSpPr>
          <p:spPr>
            <a:xfrm>
              <a:off x="7788106" y="3473515"/>
              <a:ext cx="9525" cy="224106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6" name="Group 265"/>
            <p:cNvGrpSpPr>
              <a:grpSpLocks noChangeAspect="1"/>
            </p:cNvGrpSpPr>
            <p:nvPr/>
          </p:nvGrpSpPr>
          <p:grpSpPr>
            <a:xfrm>
              <a:off x="6536044" y="729424"/>
              <a:ext cx="4703240" cy="2029018"/>
              <a:chOff x="6309170" y="265635"/>
              <a:chExt cx="7176448" cy="3095981"/>
            </a:xfrm>
          </p:grpSpPr>
          <p:pic>
            <p:nvPicPr>
              <p:cNvPr id="260" name="Picture 288" descr="https://img.jgi.doe.gov/w/tmp/ScaffoldPanel.gn.orth.641228479.1834483.x.1835007.29295.png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22818" y="2675816"/>
                <a:ext cx="7162800" cy="6858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1" name="Picture 360" descr="https://img.jgi.doe.gov/w/tmp/ScaffoldPanel.gn.orth.2526185302.2156156.x.2156608.29295.png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22818" y="2149560"/>
                <a:ext cx="7162800" cy="6858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2" name="Picture 476" descr="https://img.jgi.doe.gov/w/tmp/ScaffoldPanel.gn.orth.637000153.603385.x.603840.29295.png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09170" y="1661048"/>
                <a:ext cx="7162800" cy="6858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3" name="Picture 534" descr="https://img.jgi.doe.gov/w/tmp/ScaffoldPanel.gn.orth.2509891664.1318647.x.1319078.29295.png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09170" y="1189560"/>
                <a:ext cx="7162800" cy="6858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4" name="Picture 598" descr="https://img.jgi.doe.gov/w/tmp/ScaffoldPanel.gn.orth.637000604.3439299.x.3439745.29295.png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09170" y="722835"/>
                <a:ext cx="7162800" cy="6858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5" name="Picture 667" descr="https://img.jgi.doe.gov/w/tmp/ScaffoldPanel.gn.orth.640753032.897530.x.897994.29295.png"/>
              <p:cNvPicPr>
                <a:picLocks noChangeAspect="1"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09170" y="265635"/>
                <a:ext cx="7162800" cy="6858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67" name="TextBox 266"/>
            <p:cNvSpPr txBox="1"/>
            <p:nvPr/>
          </p:nvSpPr>
          <p:spPr>
            <a:xfrm>
              <a:off x="8557063" y="433061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KatG</a:t>
              </a:r>
              <a:endParaRPr lang="en-US" sz="1200" b="1" dirty="0"/>
            </a:p>
          </p:txBody>
        </p:sp>
        <p:cxnSp>
          <p:nvCxnSpPr>
            <p:cNvPr id="268" name="Straight Arrow Connector 267"/>
            <p:cNvCxnSpPr/>
            <p:nvPr/>
          </p:nvCxnSpPr>
          <p:spPr>
            <a:xfrm>
              <a:off x="8774634" y="651406"/>
              <a:ext cx="9525" cy="224106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9" name="TextBox 268"/>
            <p:cNvSpPr txBox="1"/>
            <p:nvPr/>
          </p:nvSpPr>
          <p:spPr>
            <a:xfrm>
              <a:off x="8412679" y="2805092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KatA</a:t>
              </a:r>
              <a:endParaRPr lang="en-US" sz="1200" b="1" dirty="0"/>
            </a:p>
          </p:txBody>
        </p:sp>
        <p:cxnSp>
          <p:nvCxnSpPr>
            <p:cNvPr id="270" name="Straight Arrow Connector 269"/>
            <p:cNvCxnSpPr/>
            <p:nvPr/>
          </p:nvCxnSpPr>
          <p:spPr>
            <a:xfrm flipH="1" flipV="1">
              <a:off x="8733024" y="2625673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72" name="Picture 622" descr="https://img.jgi.doe.gov/w/tmp/ScaffoldPanel.gn.orth.637000494.3141971.x.3142492.26118.png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00417" y="4315275"/>
              <a:ext cx="4480560" cy="4289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4" name="TextBox 273"/>
            <p:cNvSpPr txBox="1"/>
            <p:nvPr/>
          </p:nvSpPr>
          <p:spPr>
            <a:xfrm>
              <a:off x="7449319" y="4678336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Gcp</a:t>
              </a:r>
              <a:r>
                <a:rPr lang="en-US" sz="1200" b="1" dirty="0" smtClean="0"/>
                <a:t> &amp; </a:t>
              </a:r>
              <a:r>
                <a:rPr lang="en-US" sz="1200" b="1" dirty="0" err="1" smtClean="0"/>
                <a:t>UreG</a:t>
              </a:r>
              <a:endParaRPr lang="en-US" sz="1200" b="1" dirty="0"/>
            </a:p>
          </p:txBody>
        </p:sp>
        <p:cxnSp>
          <p:nvCxnSpPr>
            <p:cNvPr id="276" name="Straight Arrow Connector 275"/>
            <p:cNvCxnSpPr/>
            <p:nvPr/>
          </p:nvCxnSpPr>
          <p:spPr>
            <a:xfrm flipH="1" flipV="1">
              <a:off x="7792433" y="4493004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Arrow Connector 276"/>
            <p:cNvCxnSpPr/>
            <p:nvPr/>
          </p:nvCxnSpPr>
          <p:spPr>
            <a:xfrm flipH="1" flipV="1">
              <a:off x="7890241" y="4495276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78" name="Picture 8" descr="https://img.jgi.doe.gov/w/tmp/ScaffoldPanel.gn.orth.637000494.3684459.x.3684899.28956.png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99959" y="6147518"/>
              <a:ext cx="4447535" cy="425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79" name="Picture 316" descr="https://img.jgi.doe.gov/w/tmp/ScaffoldPanel.gn.orth.641228479.2169157.x.2169582.28956.png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99959" y="5832483"/>
              <a:ext cx="4447535" cy="425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0" name="Picture 537" descr="https://img.jgi.doe.gov/w/tmp/ScaffoldPanel.gn.orth.2508504279.1022335.x.1022775.28956.png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99959" y="5503660"/>
              <a:ext cx="4447535" cy="425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2" name="Picture 402" descr="https://img.jgi.doe.gov/w/tmp/ScaffoldPanel.gn.orth.2517586350.4114934.x.4115392.15792.png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91275" y="8007406"/>
              <a:ext cx="4447535" cy="425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63" name="Picture 484" descr="https://img.jgi.doe.gov/w/tmp/ScaffoldPanel.gn.orth.2526185302.2641660.x.2642052.15792.png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91275" y="7657355"/>
              <a:ext cx="4447535" cy="425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64" name="Picture 486" descr="https://img.jgi.doe.gov/w/tmp/ScaffoldPanel.gn.orth.639279321.2384667.x.2385101.16153.png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91275" y="7294112"/>
              <a:ext cx="4447535" cy="425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65" name="Picture 630" descr="https://img.jgi.doe.gov/w/tmp/ScaffoldPanel.gn.orth.637000604.78200.x.78595.15910.png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91275" y="8318016"/>
              <a:ext cx="4447535" cy="425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67" name="TextBox 366"/>
            <p:cNvSpPr txBox="1"/>
            <p:nvPr/>
          </p:nvSpPr>
          <p:spPr>
            <a:xfrm>
              <a:off x="8314742" y="6920433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ArsR</a:t>
              </a:r>
              <a:endParaRPr lang="en-US" sz="1200" b="1" dirty="0"/>
            </a:p>
          </p:txBody>
        </p:sp>
        <p:cxnSp>
          <p:nvCxnSpPr>
            <p:cNvPr id="368" name="Straight Arrow Connector 367"/>
            <p:cNvCxnSpPr/>
            <p:nvPr/>
          </p:nvCxnSpPr>
          <p:spPr>
            <a:xfrm>
              <a:off x="8544707" y="7154021"/>
              <a:ext cx="9525" cy="24651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9" name="TextBox 368"/>
            <p:cNvSpPr txBox="1"/>
            <p:nvPr/>
          </p:nvSpPr>
          <p:spPr>
            <a:xfrm>
              <a:off x="7740113" y="8773927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ZnuABC</a:t>
              </a:r>
              <a:endParaRPr lang="en-US" sz="1200" b="1" dirty="0"/>
            </a:p>
          </p:txBody>
        </p:sp>
        <p:cxnSp>
          <p:nvCxnSpPr>
            <p:cNvPr id="371" name="Straight Arrow Connector 370"/>
            <p:cNvCxnSpPr/>
            <p:nvPr/>
          </p:nvCxnSpPr>
          <p:spPr>
            <a:xfrm flipH="1" flipV="1">
              <a:off x="7996945" y="8551307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Straight Arrow Connector 371"/>
            <p:cNvCxnSpPr/>
            <p:nvPr/>
          </p:nvCxnSpPr>
          <p:spPr>
            <a:xfrm flipH="1" flipV="1">
              <a:off x="8081106" y="8553579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Straight Arrow Connector 372"/>
            <p:cNvCxnSpPr/>
            <p:nvPr/>
          </p:nvCxnSpPr>
          <p:spPr>
            <a:xfrm flipH="1" flipV="1">
              <a:off x="8151618" y="8555851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4" name="Straight Arrow Connector 373"/>
            <p:cNvCxnSpPr/>
            <p:nvPr/>
          </p:nvCxnSpPr>
          <p:spPr>
            <a:xfrm flipH="1" flipV="1">
              <a:off x="7921877" y="8558123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5" name="TextBox 374"/>
            <p:cNvSpPr txBox="1"/>
            <p:nvPr/>
          </p:nvSpPr>
          <p:spPr>
            <a:xfrm>
              <a:off x="1857375" y="1779429"/>
              <a:ext cx="1143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ur</a:t>
              </a:r>
              <a:endParaRPr lang="en-US" b="1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543154" y="3251273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err="1" smtClean="0"/>
                <a:t>Nur</a:t>
              </a:r>
              <a:endParaRPr lang="en-US" sz="1200" b="1" dirty="0"/>
            </a:p>
          </p:txBody>
        </p:sp>
        <p:cxnSp>
          <p:nvCxnSpPr>
            <p:cNvPr id="51" name="Straight Arrow Connector 50"/>
            <p:cNvCxnSpPr/>
            <p:nvPr/>
          </p:nvCxnSpPr>
          <p:spPr>
            <a:xfrm>
              <a:off x="7698841" y="3471487"/>
              <a:ext cx="9525" cy="224106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flipH="1" flipV="1">
              <a:off x="7737383" y="6436552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6708453" y="6629062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err="1" smtClean="0"/>
                <a:t>PerR</a:t>
              </a:r>
              <a:endParaRPr lang="en-US" sz="1200" b="1" dirty="0"/>
            </a:p>
          </p:txBody>
        </p:sp>
        <p:cxnSp>
          <p:nvCxnSpPr>
            <p:cNvPr id="54" name="Straight Arrow Connector 53"/>
            <p:cNvCxnSpPr/>
            <p:nvPr/>
          </p:nvCxnSpPr>
          <p:spPr>
            <a:xfrm flipH="1" flipV="1">
              <a:off x="8592305" y="8524675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7563375" y="8717185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err="1" smtClean="0"/>
                <a:t>Zur</a:t>
              </a:r>
              <a:endParaRPr lang="en-US" sz="1200" b="1" dirty="0"/>
            </a:p>
          </p:txBody>
        </p:sp>
        <p:cxnSp>
          <p:nvCxnSpPr>
            <p:cNvPr id="56" name="Straight Arrow Connector 55"/>
            <p:cNvCxnSpPr/>
            <p:nvPr/>
          </p:nvCxnSpPr>
          <p:spPr>
            <a:xfrm flipH="1" flipV="1">
              <a:off x="8892136" y="2607293"/>
              <a:ext cx="17546" cy="24543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8784159" y="2811100"/>
              <a:ext cx="12668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Fur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9530071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9</TotalTime>
  <Words>29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al Furnholm</dc:creator>
  <cp:lastModifiedBy>Teal Furnholm</cp:lastModifiedBy>
  <cp:revision>29</cp:revision>
  <dcterms:created xsi:type="dcterms:W3CDTF">2014-10-27T02:48:54Z</dcterms:created>
  <dcterms:modified xsi:type="dcterms:W3CDTF">2014-11-03T06:16:22Z</dcterms:modified>
</cp:coreProperties>
</file>